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西田 俊朗" initials="西田" lastIdx="2" clrIdx="0">
    <p:extLst>
      <p:ext uri="{19B8F6BF-5375-455C-9EA6-DF929625EA0E}">
        <p15:presenceInfo xmlns:p15="http://schemas.microsoft.com/office/powerpoint/2012/main" userId="3ea78e9d6057ba6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FF"/>
    <a:srgbClr val="66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9" autoAdjust="0"/>
    <p:restoredTop sz="94660"/>
  </p:normalViewPr>
  <p:slideViewPr>
    <p:cSldViewPr snapToGrid="0">
      <p:cViewPr varScale="1">
        <p:scale>
          <a:sx n="86" d="100"/>
          <a:sy n="86" d="100"/>
        </p:scale>
        <p:origin x="3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911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47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7349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716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987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7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3982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07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5904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7574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272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AE3AD-41B0-4B3E-850B-08FEA20C15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58BB1-AAE8-4783-BA86-A35398EB73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4071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/>
          <a:srcRect r="21053"/>
          <a:stretch/>
        </p:blipFill>
        <p:spPr>
          <a:xfrm>
            <a:off x="6290500" y="580816"/>
            <a:ext cx="5480775" cy="4095488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3"/>
          <a:srcRect r="23044"/>
          <a:stretch/>
        </p:blipFill>
        <p:spPr>
          <a:xfrm>
            <a:off x="505607" y="567662"/>
            <a:ext cx="5138239" cy="4095488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1095040" y="258890"/>
            <a:ext cx="22515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: RF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0389" y="4429082"/>
            <a:ext cx="12557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0" name="表 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3746793"/>
              </p:ext>
            </p:extLst>
          </p:nvPr>
        </p:nvGraphicFramePr>
        <p:xfrm>
          <a:off x="1187027" y="4669960"/>
          <a:ext cx="4299394" cy="77118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90854">
                  <a:extLst>
                    <a:ext uri="{9D8B030D-6E8A-4147-A177-3AD203B41FA5}">
                      <a16:colId xmlns:a16="http://schemas.microsoft.com/office/drawing/2014/main" val="732264222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2214284791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4263650541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4168279693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46507639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286475107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3026793730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14331713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1016413594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1266039624"/>
                    </a:ext>
                  </a:extLst>
                </a:gridCol>
                <a:gridCol w="390854">
                  <a:extLst>
                    <a:ext uri="{9D8B030D-6E8A-4147-A177-3AD203B41FA5}">
                      <a16:colId xmlns:a16="http://schemas.microsoft.com/office/drawing/2014/main" val="4242715776"/>
                    </a:ext>
                  </a:extLst>
                </a:gridCol>
              </a:tblGrid>
              <a:tr h="25706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5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8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8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7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5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3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02807691"/>
                  </a:ext>
                </a:extLst>
              </a:tr>
              <a:tr h="25706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7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7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4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1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6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54591418"/>
                  </a:ext>
                </a:extLst>
              </a:tr>
              <a:tr h="25706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5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7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4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41316485"/>
                  </a:ext>
                </a:extLst>
              </a:tr>
            </a:tbl>
          </a:graphicData>
        </a:graphic>
      </p:graphicFrame>
      <p:sp>
        <p:nvSpPr>
          <p:cNvPr id="61" name="テキスト ボックス 60"/>
          <p:cNvSpPr txBox="1"/>
          <p:nvPr/>
        </p:nvSpPr>
        <p:spPr>
          <a:xfrm>
            <a:off x="246482" y="5715485"/>
            <a:ext cx="1172281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       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RFS and OS after surgery according to various adjuvant therapy 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urations</a:t>
            </a:r>
            <a:r>
              <a: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　  </a:t>
            </a:r>
            <a:endParaRPr kumimoji="1"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atients of reevaluated report of tumor rupture based on the universal definition, excluding relapsed patients during adjuvant therapy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247186" y="4660563"/>
            <a:ext cx="10733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ess than 1y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246482" y="4926506"/>
            <a:ext cx="8024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y to 3y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246482" y="5179539"/>
            <a:ext cx="14007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More than 3y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線コネクタ 64"/>
          <p:cNvCxnSpPr/>
          <p:nvPr/>
        </p:nvCxnSpPr>
        <p:spPr>
          <a:xfrm>
            <a:off x="1485310" y="3713838"/>
            <a:ext cx="339305" cy="5751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1485310" y="3432176"/>
            <a:ext cx="339305" cy="5751"/>
          </a:xfrm>
          <a:prstGeom prst="line">
            <a:avLst/>
          </a:prstGeom>
          <a:ln w="19050">
            <a:solidFill>
              <a:schemeClr val="accent5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/>
          <p:cNvSpPr txBox="1"/>
          <p:nvPr/>
        </p:nvSpPr>
        <p:spPr>
          <a:xfrm>
            <a:off x="1778407" y="3570675"/>
            <a:ext cx="787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y to 3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1778406" y="3293676"/>
            <a:ext cx="14866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ess than 1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3710844" y="3592213"/>
            <a:ext cx="1129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0.051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線コネクタ 69"/>
          <p:cNvCxnSpPr/>
          <p:nvPr/>
        </p:nvCxnSpPr>
        <p:spPr>
          <a:xfrm>
            <a:off x="1485306" y="3985983"/>
            <a:ext cx="339305" cy="5751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/>
          <p:cNvSpPr txBox="1"/>
          <p:nvPr/>
        </p:nvSpPr>
        <p:spPr>
          <a:xfrm>
            <a:off x="1778406" y="3862752"/>
            <a:ext cx="14866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re than 3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1263416" y="3003074"/>
            <a:ext cx="2089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djuvant therapy durat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右大かっこ 72"/>
          <p:cNvSpPr/>
          <p:nvPr/>
        </p:nvSpPr>
        <p:spPr>
          <a:xfrm>
            <a:off x="3137189" y="3429518"/>
            <a:ext cx="87657" cy="551787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4" name="右大かっこ 73"/>
          <p:cNvSpPr/>
          <p:nvPr/>
        </p:nvSpPr>
        <p:spPr>
          <a:xfrm>
            <a:off x="2858341" y="3432176"/>
            <a:ext cx="90037" cy="263824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2891757" y="3447096"/>
            <a:ext cx="3585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a)</a:t>
            </a:r>
            <a:endParaRPr kumimoji="1" lang="ja-JP" altLang="en-US" sz="900" dirty="0"/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2891758" y="3744894"/>
            <a:ext cx="3469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b)</a:t>
            </a:r>
            <a:endParaRPr kumimoji="1" lang="ja-JP" altLang="en-US" sz="900" dirty="0"/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3181017" y="3593758"/>
            <a:ext cx="3469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c)</a:t>
            </a:r>
            <a:endParaRPr kumimoji="1" lang="ja-JP" altLang="en-US" sz="900" dirty="0"/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3710844" y="3370157"/>
            <a:ext cx="1129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0.13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3706925" y="3823266"/>
            <a:ext cx="1129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=0.008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右大かっこ 79"/>
          <p:cNvSpPr/>
          <p:nvPr/>
        </p:nvSpPr>
        <p:spPr>
          <a:xfrm>
            <a:off x="2859743" y="3735574"/>
            <a:ext cx="90037" cy="263824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6886925" y="222358"/>
            <a:ext cx="1455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: O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5878553" y="4400173"/>
            <a:ext cx="13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3" name="表 5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9135040"/>
              </p:ext>
            </p:extLst>
          </p:nvPr>
        </p:nvGraphicFramePr>
        <p:xfrm>
          <a:off x="7012500" y="4677172"/>
          <a:ext cx="4460731" cy="75316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05521">
                  <a:extLst>
                    <a:ext uri="{9D8B030D-6E8A-4147-A177-3AD203B41FA5}">
                      <a16:colId xmlns:a16="http://schemas.microsoft.com/office/drawing/2014/main" val="732264222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2214284791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4263650541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4168279693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46507639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286475107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3026793730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14331713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1016413594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1266039624"/>
                    </a:ext>
                  </a:extLst>
                </a:gridCol>
                <a:gridCol w="405521">
                  <a:extLst>
                    <a:ext uri="{9D8B030D-6E8A-4147-A177-3AD203B41FA5}">
                      <a16:colId xmlns:a16="http://schemas.microsoft.com/office/drawing/2014/main" val="4242715776"/>
                    </a:ext>
                  </a:extLst>
                </a:gridCol>
              </a:tblGrid>
              <a:tr h="25105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5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3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1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8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6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7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6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4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02807691"/>
                  </a:ext>
                </a:extLst>
              </a:tr>
              <a:tr h="25105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7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7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6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5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9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4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5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1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54591418"/>
                  </a:ext>
                </a:extLst>
              </a:tr>
              <a:tr h="25105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22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9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6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4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/>
                        <a:t>0</a:t>
                      </a:r>
                      <a:endParaRPr kumimoji="1" lang="ja-JP" altLang="en-US" sz="900" b="1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41316485"/>
                  </a:ext>
                </a:extLst>
              </a:tr>
            </a:tbl>
          </a:graphicData>
        </a:graphic>
      </p:graphicFrame>
      <p:sp>
        <p:nvSpPr>
          <p:cNvPr id="54" name="テキスト ボックス 53"/>
          <p:cNvSpPr txBox="1"/>
          <p:nvPr/>
        </p:nvSpPr>
        <p:spPr>
          <a:xfrm>
            <a:off x="5998423" y="4657303"/>
            <a:ext cx="10140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ess than 1y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5984424" y="4922712"/>
            <a:ext cx="8299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1y to 3y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線コネクタ 55"/>
          <p:cNvCxnSpPr/>
          <p:nvPr/>
        </p:nvCxnSpPr>
        <p:spPr>
          <a:xfrm>
            <a:off x="7335181" y="3482010"/>
            <a:ext cx="339305" cy="5751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7335181" y="3200348"/>
            <a:ext cx="339305" cy="5751"/>
          </a:xfrm>
          <a:prstGeom prst="line">
            <a:avLst/>
          </a:prstGeom>
          <a:ln w="19050">
            <a:solidFill>
              <a:schemeClr val="accent5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/>
          <p:cNvSpPr txBox="1"/>
          <p:nvPr/>
        </p:nvSpPr>
        <p:spPr>
          <a:xfrm>
            <a:off x="7628278" y="3338847"/>
            <a:ext cx="787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y to 3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7628277" y="3061848"/>
            <a:ext cx="14866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ess than 1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9560715" y="3360385"/>
            <a:ext cx="1129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0.48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直線コネクタ 81"/>
          <p:cNvCxnSpPr/>
          <p:nvPr/>
        </p:nvCxnSpPr>
        <p:spPr>
          <a:xfrm>
            <a:off x="7335177" y="3754155"/>
            <a:ext cx="339305" cy="5751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/>
          <p:cNvSpPr txBox="1"/>
          <p:nvPr/>
        </p:nvSpPr>
        <p:spPr>
          <a:xfrm>
            <a:off x="7628277" y="3630924"/>
            <a:ext cx="14866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re than 3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7113287" y="2771246"/>
            <a:ext cx="2089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djuvant therapy durat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右大かっこ 84"/>
          <p:cNvSpPr/>
          <p:nvPr/>
        </p:nvSpPr>
        <p:spPr>
          <a:xfrm>
            <a:off x="8987060" y="3197690"/>
            <a:ext cx="87657" cy="551787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6" name="右大かっこ 85"/>
          <p:cNvSpPr/>
          <p:nvPr/>
        </p:nvSpPr>
        <p:spPr>
          <a:xfrm>
            <a:off x="8708212" y="3200348"/>
            <a:ext cx="90037" cy="263824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8741628" y="3215268"/>
            <a:ext cx="3443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a)</a:t>
            </a:r>
            <a:endParaRPr kumimoji="1" lang="ja-JP" altLang="en-US" sz="900" dirty="0"/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8741629" y="3513066"/>
            <a:ext cx="3469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b)</a:t>
            </a:r>
            <a:endParaRPr kumimoji="1" lang="ja-JP" altLang="en-US" sz="900" dirty="0"/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9030888" y="3361930"/>
            <a:ext cx="3469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/>
              <a:t>c)</a:t>
            </a:r>
            <a:endParaRPr kumimoji="1" lang="ja-JP" altLang="en-US" sz="900" dirty="0"/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9560715" y="3138329"/>
            <a:ext cx="1129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0.24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9556796" y="3567214"/>
            <a:ext cx="1129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0.53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5984424" y="5161921"/>
            <a:ext cx="10420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More than 3y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右大かっこ 92"/>
          <p:cNvSpPr/>
          <p:nvPr/>
        </p:nvSpPr>
        <p:spPr>
          <a:xfrm>
            <a:off x="8709614" y="3503746"/>
            <a:ext cx="90037" cy="263824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5497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8</TotalTime>
  <Words>188</Words>
  <Application>Microsoft Office PowerPoint</Application>
  <PresentationFormat>ワイド画面</PresentationFormat>
  <Paragraphs>9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to Gotohda</dc:creator>
  <cp:lastModifiedBy>Naoto Gotohda</cp:lastModifiedBy>
  <cp:revision>162</cp:revision>
  <cp:lastPrinted>2022-12-05T05:04:51Z</cp:lastPrinted>
  <dcterms:created xsi:type="dcterms:W3CDTF">2022-08-26T05:47:00Z</dcterms:created>
  <dcterms:modified xsi:type="dcterms:W3CDTF">2023-04-07T03:12:41Z</dcterms:modified>
</cp:coreProperties>
</file>